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C4EC29-7CFF-472B-92F5-C08C2D0485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6A5332-9BA8-4AD6-A733-4FF4517A23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07583A-04BD-4345-82A2-4A206E9754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0837B5-D79C-4F37-A9CE-F95A026B73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F401F-771E-46F2-8F59-3FE72D27A0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D5E4B-8EAB-4601-BF2D-6CE92AE89C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C6646-502F-4467-B564-D9B2D422E6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70AD9-5CBC-45AF-A748-57250D13CC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7A734-4DC6-424D-9ED3-9EF88BAA42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668C8-D5D0-479A-B999-94797ADAE8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EDBA33-566F-4137-BA21-D675F4B67E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DA9343-46EA-4101-BE16-E9751EBA53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4618B2-37CD-4B89-80BF-093AC0A5EED0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11280" y="260280"/>
            <a:ext cx="8362800" cy="346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Figure S1 : Example of referral pathway for antenatal women with HBV( HBsAg positiv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2" name="AutoShape 18"/>
          <p:cNvCxnSpPr>
            <a:endCxn id="43" idx="0"/>
          </p:cNvCxnSpPr>
          <p:nvPr/>
        </p:nvCxnSpPr>
        <p:spPr>
          <a:xfrm>
            <a:off x="5724000" y="3499920"/>
            <a:ext cx="1320120" cy="577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4" name="AutoShape 6"/>
          <p:cNvCxnSpPr>
            <a:stCxn id="45" idx="1"/>
          </p:cNvCxnSpPr>
          <p:nvPr/>
        </p:nvCxnSpPr>
        <p:spPr>
          <a:xfrm flipH="1">
            <a:off x="2770920" y="3429000"/>
            <a:ext cx="1080720" cy="5767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6" name="AutoShape 14"/>
          <p:cNvCxnSpPr/>
          <p:nvPr/>
        </p:nvCxnSpPr>
        <p:spPr>
          <a:xfrm>
            <a:off x="2410920" y="5084280"/>
            <a:ext cx="1080" cy="505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7" name="AutoShape 9"/>
          <p:cNvCxnSpPr/>
          <p:nvPr/>
        </p:nvCxnSpPr>
        <p:spPr>
          <a:xfrm>
            <a:off x="7164360" y="4723920"/>
            <a:ext cx="2160" cy="793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8" name="Text Box 16"/>
          <p:cNvSpPr/>
          <p:nvPr/>
        </p:nvSpPr>
        <p:spPr>
          <a:xfrm>
            <a:off x="3714840" y="831960"/>
            <a:ext cx="2009520" cy="652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ff3300"/>
                </a:solidFill>
                <a:latin typeface="Arial"/>
              </a:rPr>
              <a:t>Antenatal  clinic ( AN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Booking bloods after verbal cons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5"/>
          <p:cNvSpPr/>
          <p:nvPr/>
        </p:nvSpPr>
        <p:spPr>
          <a:xfrm>
            <a:off x="2987640" y="1916280"/>
            <a:ext cx="3529080" cy="7570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ff3300"/>
                </a:solidFill>
                <a:latin typeface="Arial"/>
              </a:rPr>
              <a:t>Virolo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HBsAg+, confirm results, serological markers of infection, viral load ( HBV DN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2"/>
          <p:cNvSpPr/>
          <p:nvPr/>
        </p:nvSpPr>
        <p:spPr>
          <a:xfrm>
            <a:off x="1476360" y="4005360"/>
            <a:ext cx="1862280" cy="1079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ff3300"/>
                </a:solidFill>
                <a:latin typeface="Arial"/>
              </a:rPr>
              <a:t>Antenatal  Tea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vice for mother and  baby documented in birth plan( vaccine, HBIG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8"/>
          <p:cNvSpPr/>
          <p:nvPr/>
        </p:nvSpPr>
        <p:spPr>
          <a:xfrm>
            <a:off x="6300720" y="4076640"/>
            <a:ext cx="1486080" cy="576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ff3300"/>
                </a:solidFill>
                <a:latin typeface="Arial"/>
              </a:rPr>
              <a:t>Neonatolo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Letter of referra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1"/>
          <p:cNvSpPr/>
          <p:nvPr/>
        </p:nvSpPr>
        <p:spPr>
          <a:xfrm>
            <a:off x="900000" y="5589720"/>
            <a:ext cx="2808360" cy="1079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buClr>
                <a:srgbClr val="ff33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ff3300"/>
                </a:solidFill>
                <a:latin typeface="Arial"/>
              </a:rPr>
              <a:t>Maternal referral  to Hepatology/ specialist services for screening of other viruses, antivirals, screening of family et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ff33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ff3300"/>
                </a:solidFill>
                <a:latin typeface="Arial"/>
              </a:rPr>
              <a:t>Inform G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ff33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7"/>
          <p:cNvSpPr/>
          <p:nvPr/>
        </p:nvSpPr>
        <p:spPr>
          <a:xfrm>
            <a:off x="5796000" y="5589720"/>
            <a:ext cx="2305080" cy="1008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Vaccination +/ HBIG  to the baby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ff3300"/>
                </a:solidFill>
                <a:latin typeface="Arial"/>
              </a:rPr>
              <a:t>Refer to GP/ community services/paediatrics for follow up upto 1 yea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3" name="AutoShape 10"/>
          <p:cNvCxnSpPr/>
          <p:nvPr/>
        </p:nvCxnSpPr>
        <p:spPr>
          <a:xfrm>
            <a:off x="3564000" y="4508280"/>
            <a:ext cx="2448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4" name="Rectangle 19"/>
          <p:cNvSpPr/>
          <p:nvPr/>
        </p:nvSpPr>
        <p:spPr>
          <a:xfrm>
            <a:off x="2001960" y="288000"/>
            <a:ext cx="18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9"/>
          <p:cNvSpPr/>
          <p:nvPr/>
        </p:nvSpPr>
        <p:spPr>
          <a:xfrm>
            <a:off x="611280" y="2276640"/>
            <a:ext cx="143964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21"/>
          <p:cNvSpPr/>
          <p:nvPr/>
        </p:nvSpPr>
        <p:spPr>
          <a:xfrm flipH="1">
            <a:off x="2484360" y="2565360"/>
            <a:ext cx="432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AutoShape 22"/>
          <p:cNvSpPr/>
          <p:nvPr/>
        </p:nvSpPr>
        <p:spPr>
          <a:xfrm>
            <a:off x="250920" y="2276640"/>
            <a:ext cx="2016000" cy="790560"/>
          </a:xfrm>
          <a:prstGeom prst="flowChartProcess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ff0000"/>
                </a:solidFill>
                <a:latin typeface="Arial"/>
              </a:rPr>
              <a:t>Pharmac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y vaccine/ HBIG t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NC/ neonatolo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23"/>
          <p:cNvSpPr/>
          <p:nvPr/>
        </p:nvSpPr>
        <p:spPr>
          <a:xfrm>
            <a:off x="3851280" y="3141720"/>
            <a:ext cx="1944720" cy="574560"/>
          </a:xfrm>
          <a:prstGeom prst="rect">
            <a:avLst/>
          </a:prstGeom>
          <a:solidFill>
            <a:srgbClr val="bbe0e3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Virology results emailed /posted /telephon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eft-Right-Up Arrow 38"/>
          <p:cNvSpPr/>
          <p:nvPr/>
        </p:nvSpPr>
        <p:spPr>
          <a:xfrm>
            <a:off x="4140360" y="5373720"/>
            <a:ext cx="1215720" cy="849240"/>
          </a:xfrm>
          <a:custGeom>
            <a:avLst/>
            <a:gdLst/>
            <a:ahLst/>
            <a:rect l="l" t="t" r="r" b="b"/>
            <a:pathLst>
              <a:path w="1216025" h="849312">
                <a:moveTo>
                  <a:pt x="0" y="636984"/>
                </a:moveTo>
                <a:lnTo>
                  <a:pt x="212328" y="424656"/>
                </a:lnTo>
                <a:lnTo>
                  <a:pt x="212328" y="530820"/>
                </a:lnTo>
                <a:lnTo>
                  <a:pt x="501849" y="530820"/>
                </a:lnTo>
                <a:lnTo>
                  <a:pt x="501849" y="212328"/>
                </a:lnTo>
                <a:lnTo>
                  <a:pt x="395685" y="212328"/>
                </a:lnTo>
                <a:lnTo>
                  <a:pt x="608013" y="0"/>
                </a:lnTo>
                <a:lnTo>
                  <a:pt x="820341" y="212328"/>
                </a:lnTo>
                <a:lnTo>
                  <a:pt x="714177" y="212328"/>
                </a:lnTo>
                <a:lnTo>
                  <a:pt x="714177" y="530820"/>
                </a:lnTo>
                <a:lnTo>
                  <a:pt x="1003697" y="530820"/>
                </a:lnTo>
                <a:lnTo>
                  <a:pt x="1003697" y="424656"/>
                </a:lnTo>
                <a:lnTo>
                  <a:pt x="1216025" y="636984"/>
                </a:lnTo>
                <a:lnTo>
                  <a:pt x="1003697" y="849312"/>
                </a:lnTo>
                <a:lnTo>
                  <a:pt x="1003697" y="743148"/>
                </a:lnTo>
                <a:lnTo>
                  <a:pt x="212328" y="743148"/>
                </a:lnTo>
                <a:lnTo>
                  <a:pt x="212328" y="849312"/>
                </a:lnTo>
                <a:lnTo>
                  <a:pt x="0" y="636984"/>
                </a:lnTo>
                <a:close/>
              </a:path>
            </a:pathLst>
          </a:custGeom>
          <a:solidFill>
            <a:srgbClr val="bbe0e3"/>
          </a:solidFill>
          <a:ln w="25560">
            <a:solidFill>
              <a:srgbClr val="89a4a7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Down Arrow 41"/>
          <p:cNvSpPr/>
          <p:nvPr/>
        </p:nvSpPr>
        <p:spPr>
          <a:xfrm>
            <a:off x="4500720" y="1557360"/>
            <a:ext cx="484200" cy="35892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Down Arrow 42"/>
          <p:cNvSpPr/>
          <p:nvPr/>
        </p:nvSpPr>
        <p:spPr>
          <a:xfrm>
            <a:off x="4500720" y="2708280"/>
            <a:ext cx="484200" cy="43344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21T15:36:49Z</dcterms:created>
  <dc:creator>ggodbole</dc:creator>
  <dc:description/>
  <dc:language>en-US</dc:language>
  <cp:lastModifiedBy>Gauri Godbole</cp:lastModifiedBy>
  <dcterms:modified xsi:type="dcterms:W3CDTF">2013-07-30T20:16:16Z</dcterms:modified>
  <cp:revision>185</cp:revision>
  <dc:subject/>
  <dc:title>Slide 1</dc:title>
</cp:coreProperties>
</file>